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6" r:id="rId3"/>
    <p:sldId id="257" r:id="rId4"/>
    <p:sldId id="258" r:id="rId5"/>
    <p:sldId id="259" r:id="rId6"/>
    <p:sldId id="260" r:id="rId7"/>
    <p:sldId id="261" r:id="rId8"/>
    <p:sldId id="265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849" autoAdjust="0"/>
  </p:normalViewPr>
  <p:slideViewPr>
    <p:cSldViewPr>
      <p:cViewPr>
        <p:scale>
          <a:sx n="112" d="100"/>
          <a:sy n="112" d="100"/>
        </p:scale>
        <p:origin x="-78" y="9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pkgupta36@gmail.com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Rectangle 1"/>
          <p:cNvSpPr>
            <a:spLocks noChangeArrowheads="1"/>
          </p:cNvSpPr>
          <p:nvPr/>
        </p:nvSpPr>
        <p:spPr bwMode="auto">
          <a:xfrm>
            <a:off x="1371600" y="1295400"/>
            <a:ext cx="6324600" cy="18158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dentification and characterization of SET domain family genes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 bread wheat (</a:t>
            </a:r>
            <a:r>
              <a:rPr kumimoji="0" lang="en-US" sz="14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riticum</a:t>
            </a:r>
            <a:r>
              <a:rPr kumimoji="0" lang="en-US" sz="14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400" b="1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estivum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L.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Ritu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Batra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inku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Gautam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unita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al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epti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Chaturvedi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Rakhi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rfat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Jan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H. S. Balyan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, and P.K. Gupta*</a:t>
            </a: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1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partment of Genetics and Plant Breeding, CCS University, Meerut-250004, Uttar Pradesh, India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Corresponding author email id: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  <a:hlinkClick r:id="rId2"/>
              </a:rPr>
              <a:t>pkgupta36@gmail.com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PKG)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*Corresponding author ORCID id: 0000-0001-7638-6171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Win 8.1\Desktop\SET 2019\SET paper\Figures\Fig S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95400" y="1295401"/>
            <a:ext cx="6738947" cy="2133599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371600" y="3886200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intron structure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elonging to class I. Exons are represented by blue boxes, Introns are represented in black lines and UTRs are represented by red thick lines. 0 indicates an intron located between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1 indicates an intron inserted at the first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2 indicate an intron inserted at the second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drawn using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tructure Display Server (GSDS) v2.0 [69]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Win 8.1\Desktop\SET 2019\SET paper\Figures\Fig S2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600" y="1068000"/>
            <a:ext cx="6248400" cy="2970600"/>
          </a:xfrm>
          <a:prstGeom prst="rect">
            <a:avLst/>
          </a:prstGeom>
          <a:noFill/>
        </p:spPr>
      </p:pic>
      <p:sp>
        <p:nvSpPr>
          <p:cNvPr id="4" name="Rectangle 3"/>
          <p:cNvSpPr/>
          <p:nvPr/>
        </p:nvSpPr>
        <p:spPr>
          <a:xfrm>
            <a:off x="1447800" y="4267200"/>
            <a:ext cx="6172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b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intron structure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elonging to class II. Exons are represented by blue boxes, Introns are represented in black lines and UTRs are represented by red thick lines. 0 indicates an intron located between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1 indicates an intron inserted at the first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2 indicate an intron inserted at the second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draw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sing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tructure Display Server (GSDS) v2.0 [69]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Win 8.1\Desktop\SET 2019\SET paper\Figures\Fig S3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19200" y="1219200"/>
            <a:ext cx="6172200" cy="3200400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1219200" y="4494074"/>
            <a:ext cx="70866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c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intron structure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elonging to class III. Exons are represented by blue boxes, Introns are represented in black lines and UTRs are represented by red thick lines. 0 indicates an intron located between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1 indicates an intron inserted at the first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2 indicate an intron inserted at the second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drawn using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tructure Display Server (GSDS) v2.0 [69]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Win 8.1\Desktop\SET 2019\SET paper\Figures\Fig S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1600200"/>
            <a:ext cx="7206761" cy="1676400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990600" y="4494074"/>
            <a:ext cx="71628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intron structure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elonging to class IV. Exons are represented by blue boxes, Introns are represented in black lines and UTRs are represented by red thick lines. 0 indicates an intron located between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1 indicates an intron inserted at the first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2 indicate an intron inserted at the second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draw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sing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tructure Display Server (GSDS) v2.0 [69]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Win 8.1\Desktop\SET 2019\SET paper\Figures\Fig S5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2000" y="76200"/>
            <a:ext cx="6858000" cy="6019800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762000" y="6019800"/>
            <a:ext cx="8153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intron structure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elonging to class V. Exons are represented by blue boxes, Introns are represented in black lines and UTRs are represented by red thick lines. 0 indicates an intron located between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1 indicates an intron inserted at the first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2 indicate an intron inserted at the second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draw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sing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tructure Display Server (GSDS) v2.0 [69]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C:\Users\Win 8.1\Desktop\SET 2019\SET paper\Figures\Fig S6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5800" y="1371600"/>
            <a:ext cx="7391400" cy="1524000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685800" y="3163669"/>
            <a:ext cx="81534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x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–intron structures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elonging to class VII. Exons are represented by blue boxes, Introns are represented in black lines and UTRs are represented by red thick lines. 0 indicates an intron located between two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1 indicates an intron inserted at the first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, 2 indicate an intron inserted at the second base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od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Figure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drawn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using </a:t>
            </a:r>
            <a:r>
              <a:rPr lang="en-IN" sz="1200" dirty="0" smtClean="0">
                <a:latin typeface="Times New Roman" pitchFamily="18" charset="0"/>
                <a:cs typeface="Times New Roman" pitchFamily="18" charset="0"/>
              </a:rPr>
              <a:t>Gene Structure Display Server (GSDS) v2.0 [69]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Win 8.1\Desktop\SET 2019\SET paper\Documents to submit\Figures\Gupta MS Figure 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43000" y="1208400"/>
            <a:ext cx="7333846" cy="4430400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3352800" y="5742801"/>
            <a:ext cx="3352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2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unctional annotation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aSD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roteins.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3</TotalTime>
  <Words>590</Words>
  <Application>Microsoft Office PowerPoint</Application>
  <PresentationFormat>On-screen Show (4:3)</PresentationFormat>
  <Paragraphs>14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tu Batra</dc:creator>
  <cp:lastModifiedBy>Ritu Batra</cp:lastModifiedBy>
  <cp:revision>15</cp:revision>
  <dcterms:created xsi:type="dcterms:W3CDTF">2006-08-16T00:00:00Z</dcterms:created>
  <dcterms:modified xsi:type="dcterms:W3CDTF">2020-08-01T11:42:17Z</dcterms:modified>
</cp:coreProperties>
</file>